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18866-2805-4B58-9053-35C124016E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20A2CE-06C0-428A-8FA6-FC4D37FEE0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C7F6F-D3CC-48FB-B94D-4E5DB6AB0B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36737C-34A4-4BE5-9A95-64E5B860A9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962F2-92AD-435E-96EB-4BD5A188D1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ADAC5-D1A3-402E-B714-C40C0E04C1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C53A57-852D-45DD-AA0A-5D63840F3E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86ABF-8AAE-455F-9FB0-4267A4EDBA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54258-878E-47BA-A0AB-84E1AE1870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CB61B-F0F0-47C6-B698-71450374CE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6F156-742B-455F-AEB6-C3B33391D2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121F5-4FF3-476E-A947-0A95BBA1D9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F7E289-7EF9-4C8B-B60B-878920228A4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52640" y="9286920"/>
            <a:ext cx="1341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6080" y="5724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1916280" y="3872880"/>
            <a:ext cx="3116520" cy="1875600"/>
            <a:chOff x="1916280" y="3872880"/>
            <a:chExt cx="3116520" cy="1875600"/>
          </a:xfrm>
        </p:grpSpPr>
        <p:pic>
          <p:nvPicPr>
            <p:cNvPr id="44" name="" descr=""/>
            <p:cNvPicPr/>
            <p:nvPr/>
          </p:nvPicPr>
          <p:blipFill>
            <a:blip r:embed="rId1"/>
            <a:srcRect l="6978" t="20019" r="48390" b="11996"/>
            <a:stretch/>
          </p:blipFill>
          <p:spPr>
            <a:xfrm>
              <a:off x="3511440" y="4189320"/>
              <a:ext cx="1512360" cy="1341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45" name=""/>
            <p:cNvSpPr/>
            <p:nvPr/>
          </p:nvSpPr>
          <p:spPr>
            <a:xfrm>
              <a:off x="4529160" y="5457960"/>
              <a:ext cx="431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519800" y="5502240"/>
              <a:ext cx="51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Times New Roman"/>
                </a:rPr>
                <a:t>20 </a:t>
              </a:r>
              <a:r>
                <a:rPr b="0" lang="es-E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s-ES" sz="1000" spc="-1" strike="noStrike">
                  <a:solidFill>
                    <a:srgbClr val="000000"/>
                  </a:solidFill>
                  <a:latin typeface="Times New Roman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V="1" rot="10800000">
              <a:off x="2152800" y="3872880"/>
              <a:ext cx="1060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-III Tubu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997360" y="5502240"/>
              <a:ext cx="51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Times New Roman"/>
                </a:rPr>
                <a:t>20 </a:t>
              </a:r>
              <a:r>
                <a:rPr b="0" lang="es-E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s-ES" sz="1000" spc="-1" strike="noStrike">
                  <a:solidFill>
                    <a:srgbClr val="000000"/>
                  </a:solidFill>
                  <a:latin typeface="Times New Roman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9" name="" descr=""/>
            <p:cNvPicPr/>
            <p:nvPr/>
          </p:nvPicPr>
          <p:blipFill>
            <a:blip r:embed="rId2"/>
            <a:stretch/>
          </p:blipFill>
          <p:spPr>
            <a:xfrm>
              <a:off x="1916280" y="4184640"/>
              <a:ext cx="1510920" cy="134460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50" name=""/>
            <p:cNvSpPr/>
            <p:nvPr/>
          </p:nvSpPr>
          <p:spPr>
            <a:xfrm>
              <a:off x="2923920" y="5481720"/>
              <a:ext cx="431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2492280" y="5192280"/>
              <a:ext cx="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927080" y="3902040"/>
              <a:ext cx="1510920" cy="2160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3" name=""/>
            <p:cNvGrpSpPr/>
            <p:nvPr/>
          </p:nvGrpSpPr>
          <p:grpSpPr>
            <a:xfrm>
              <a:off x="3512880" y="3876840"/>
              <a:ext cx="1510920" cy="276480"/>
              <a:chOff x="3512880" y="3876840"/>
              <a:chExt cx="1510920" cy="276480"/>
            </a:xfrm>
          </p:grpSpPr>
          <p:sp>
            <p:nvSpPr>
              <p:cNvPr id="54" name=""/>
              <p:cNvSpPr/>
              <p:nvPr/>
            </p:nvSpPr>
            <p:spPr>
              <a:xfrm>
                <a:off x="3512880" y="3905280"/>
                <a:ext cx="1510920" cy="21600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V="1" rot="10800000">
                <a:off x="3755160" y="3876840"/>
                <a:ext cx="1024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AS staini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6" name=""/>
          <p:cNvGrpSpPr/>
          <p:nvPr/>
        </p:nvGrpSpPr>
        <p:grpSpPr>
          <a:xfrm>
            <a:off x="69840" y="6242760"/>
            <a:ext cx="6527880" cy="2514600"/>
            <a:chOff x="69840" y="6242760"/>
            <a:chExt cx="6527880" cy="2514600"/>
          </a:xfrm>
        </p:grpSpPr>
        <p:sp>
          <p:nvSpPr>
            <p:cNvPr id="57" name=""/>
            <p:cNvSpPr/>
            <p:nvPr/>
          </p:nvSpPr>
          <p:spPr>
            <a:xfrm>
              <a:off x="69840" y="7093080"/>
              <a:ext cx="33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8" name="" descr=""/>
            <p:cNvPicPr/>
            <p:nvPr/>
          </p:nvPicPr>
          <p:blipFill>
            <a:blip r:embed="rId3"/>
            <a:srcRect l="5905" t="17790" r="0" b="0"/>
            <a:stretch/>
          </p:blipFill>
          <p:spPr>
            <a:xfrm>
              <a:off x="189000" y="6603840"/>
              <a:ext cx="2065320" cy="181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" descr=""/>
            <p:cNvPicPr/>
            <p:nvPr/>
          </p:nvPicPr>
          <p:blipFill>
            <a:blip r:embed="rId4"/>
            <a:srcRect l="5536" t="17754" r="0" b="0"/>
            <a:stretch/>
          </p:blipFill>
          <p:spPr>
            <a:xfrm>
              <a:off x="2390760" y="6603840"/>
              <a:ext cx="2087640" cy="181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" descr=""/>
            <p:cNvPicPr/>
            <p:nvPr/>
          </p:nvPicPr>
          <p:blipFill>
            <a:blip r:embed="rId5"/>
            <a:srcRect l="5536" t="17754" r="0" b="0"/>
            <a:stretch/>
          </p:blipFill>
          <p:spPr>
            <a:xfrm>
              <a:off x="4508640" y="6603840"/>
              <a:ext cx="2087280" cy="181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"/>
            <p:cNvSpPr/>
            <p:nvPr/>
          </p:nvSpPr>
          <p:spPr>
            <a:xfrm>
              <a:off x="189000" y="6255360"/>
              <a:ext cx="2087640" cy="2764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390760" y="8480880"/>
              <a:ext cx="2087640" cy="2764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Bs in the cytopla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390760" y="6242760"/>
              <a:ext cx="4206960" cy="2764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EPM2A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-/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510080" y="8480880"/>
              <a:ext cx="2087640" cy="2764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Bs in dendrit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"/>
          <p:cNvSpPr/>
          <p:nvPr/>
        </p:nvSpPr>
        <p:spPr>
          <a:xfrm>
            <a:off x="61920" y="583092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" descr=""/>
          <p:cNvPicPr/>
          <p:nvPr/>
        </p:nvPicPr>
        <p:blipFill>
          <a:blip r:embed="rId6"/>
          <a:srcRect l="21464" t="21401" r="0" b="0"/>
          <a:stretch/>
        </p:blipFill>
        <p:spPr>
          <a:xfrm>
            <a:off x="1238400" y="565200"/>
            <a:ext cx="2179440" cy="15285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67" name="" descr=""/>
          <p:cNvPicPr/>
          <p:nvPr/>
        </p:nvPicPr>
        <p:blipFill>
          <a:blip r:embed="rId7"/>
          <a:stretch/>
        </p:blipFill>
        <p:spPr>
          <a:xfrm>
            <a:off x="3481560" y="565200"/>
            <a:ext cx="2179440" cy="15285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68" name=""/>
          <p:cNvSpPr/>
          <p:nvPr/>
        </p:nvSpPr>
        <p:spPr>
          <a:xfrm>
            <a:off x="5199120" y="2046240"/>
            <a:ext cx="395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868760" y="236520"/>
            <a:ext cx="99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Times New Roman"/>
              </a:rPr>
              <a:t>3 months-ol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238400" y="233280"/>
            <a:ext cx="2178000" cy="2793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113360" y="23652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Times New Roman"/>
              </a:rPr>
              <a:t>13 months-ol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484440" y="233280"/>
            <a:ext cx="2176560" cy="2793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568440" y="1998360"/>
            <a:ext cx="98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-III 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rot="16200000">
            <a:off x="-511560" y="2025000"/>
            <a:ext cx="3144960" cy="2253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2162160" y="1305000"/>
            <a:ext cx="0" cy="123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3878280" y="1674720"/>
            <a:ext cx="0" cy="123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V="1">
            <a:off x="4540320" y="1058760"/>
            <a:ext cx="0" cy="123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5133960" y="1922400"/>
            <a:ext cx="0" cy="123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4935600" y="934920"/>
            <a:ext cx="0" cy="123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134680" y="1832040"/>
            <a:ext cx="5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Times New Roman"/>
              </a:rPr>
              <a:t>60 </a:t>
            </a:r>
            <a:r>
              <a:rPr b="1" lang="es-E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s-ES" sz="12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" descr=""/>
          <p:cNvPicPr/>
          <p:nvPr/>
        </p:nvPicPr>
        <p:blipFill>
          <a:blip r:embed="rId8"/>
          <a:srcRect l="0" t="0" r="41001" b="16771"/>
          <a:stretch/>
        </p:blipFill>
        <p:spPr>
          <a:xfrm>
            <a:off x="3483000" y="2168640"/>
            <a:ext cx="2170080" cy="15415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2" name="" descr=""/>
          <p:cNvPicPr/>
          <p:nvPr/>
        </p:nvPicPr>
        <p:blipFill>
          <a:blip r:embed="rId9"/>
          <a:srcRect l="12102" t="54455" r="36503" b="0"/>
          <a:stretch/>
        </p:blipFill>
        <p:spPr>
          <a:xfrm>
            <a:off x="1238400" y="2168640"/>
            <a:ext cx="2179440" cy="15415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grpSp>
        <p:nvGrpSpPr>
          <p:cNvPr id="83" name=""/>
          <p:cNvGrpSpPr/>
          <p:nvPr/>
        </p:nvGrpSpPr>
        <p:grpSpPr>
          <a:xfrm>
            <a:off x="5146920" y="3440160"/>
            <a:ext cx="586080" cy="276480"/>
            <a:chOff x="5146920" y="3440160"/>
            <a:chExt cx="586080" cy="276480"/>
          </a:xfrm>
        </p:grpSpPr>
        <p:sp>
          <p:nvSpPr>
            <p:cNvPr id="84" name=""/>
            <p:cNvSpPr/>
            <p:nvPr/>
          </p:nvSpPr>
          <p:spPr>
            <a:xfrm>
              <a:off x="5146920" y="3440160"/>
              <a:ext cx="58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Times New Roman"/>
                </a:rPr>
                <a:t>60 </a:t>
              </a:r>
              <a:r>
                <a:rPr b="1" lang="es-E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s-ES" sz="1200" spc="-1" strike="noStrike">
                  <a:solidFill>
                    <a:srgbClr val="000000"/>
                  </a:solidFill>
                  <a:latin typeface="Times New Roman"/>
                </a:rPr>
                <a:t>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241600" y="3681360"/>
              <a:ext cx="395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" name=""/>
          <p:cNvGrpSpPr/>
          <p:nvPr/>
        </p:nvGrpSpPr>
        <p:grpSpPr>
          <a:xfrm>
            <a:off x="5735160" y="560520"/>
            <a:ext cx="276480" cy="1512720"/>
            <a:chOff x="5735160" y="560520"/>
            <a:chExt cx="276480" cy="1512720"/>
          </a:xfrm>
        </p:grpSpPr>
        <p:sp>
          <p:nvSpPr>
            <p:cNvPr id="87" name=""/>
            <p:cNvSpPr/>
            <p:nvPr/>
          </p:nvSpPr>
          <p:spPr>
            <a:xfrm flipH="1" rot="5400000">
              <a:off x="5442480" y="1178640"/>
              <a:ext cx="86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PM2A -/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6200000">
              <a:off x="5117400" y="1185120"/>
              <a:ext cx="1512720" cy="2635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"/>
          <p:cNvGrpSpPr/>
          <p:nvPr/>
        </p:nvGrpSpPr>
        <p:grpSpPr>
          <a:xfrm>
            <a:off x="5730480" y="2144880"/>
            <a:ext cx="276480" cy="1512720"/>
            <a:chOff x="5730480" y="2144880"/>
            <a:chExt cx="276480" cy="1512720"/>
          </a:xfrm>
        </p:grpSpPr>
        <p:sp>
          <p:nvSpPr>
            <p:cNvPr id="90" name=""/>
            <p:cNvSpPr/>
            <p:nvPr/>
          </p:nvSpPr>
          <p:spPr>
            <a:xfrm flipH="1" rot="5400000">
              <a:off x="5469480" y="2762640"/>
              <a:ext cx="79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Wild-typ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6200000">
              <a:off x="5113800" y="2769480"/>
              <a:ext cx="1512720" cy="2631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1T13:28:43Z</dcterms:created>
  <dc:creator>Consellería de Sanidade-Servizo Galego de Saúde</dc:creator>
  <dc:description/>
  <dc:language>en-US</dc:language>
  <cp:lastModifiedBy>Consellería de Sanidade-Servizo Galego de Saúde</cp:lastModifiedBy>
  <dcterms:modified xsi:type="dcterms:W3CDTF">2013-11-27T11:58:47Z</dcterms:modified>
  <cp:revision>70</cp:revision>
  <dc:subject/>
  <dc:title>Diapositiva 1</dc:title>
</cp:coreProperties>
</file>